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2" d="100"/>
          <a:sy n="62" d="100"/>
        </p:scale>
        <p:origin x="79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296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282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517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70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370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295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6890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067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0169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06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6865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FBE86-F764-4300-B937-4DC71ADDF786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C38A9-6B41-4442-A11C-768896C109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6139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2051" name="Picture 4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687"/>
          <a:stretch>
            <a:fillRect/>
          </a:stretch>
        </p:blipFill>
        <p:spPr bwMode="auto">
          <a:xfrm>
            <a:off x="284934" y="871537"/>
            <a:ext cx="11907066" cy="58687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0" y="1843841"/>
            <a:ext cx="330200" cy="4921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457056" tIns="180918" rIns="457056" bIns="180918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7" name="Rectangle 7"/>
          <p:cNvSpPr>
            <a:spLocks noChangeArrowheads="1"/>
          </p:cNvSpPr>
          <p:nvPr/>
        </p:nvSpPr>
        <p:spPr bwMode="auto">
          <a:xfrm>
            <a:off x="0" y="4572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8" name="Rectangle 8"/>
          <p:cNvSpPr>
            <a:spLocks noChangeArrowheads="1"/>
          </p:cNvSpPr>
          <p:nvPr/>
        </p:nvSpPr>
        <p:spPr bwMode="auto">
          <a:xfrm>
            <a:off x="0" y="39751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0" y="39751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0" y="76517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2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/>
            </a:r>
            <a:br>
              <a:rPr kumimoji="0" lang="en-GB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0" y="-39891"/>
            <a:ext cx="1227789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GB" sz="11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</a:t>
            </a:r>
            <a:r>
              <a:rPr lang="en-GB" sz="11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ontology analysis of CSF from patients using the web-based Gene Set Analysis </a:t>
            </a:r>
            <a:r>
              <a:rPr lang="en-GB" sz="11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olkit </a:t>
            </a:r>
            <a:r>
              <a:rPr lang="en-GB" sz="11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100" dirty="0" err="1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bGestaldt</a:t>
            </a:r>
            <a:r>
              <a:rPr lang="en-GB" sz="11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1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4080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8</TotalTime>
  <Words>24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C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dy Heywood</dc:creator>
  <cp:lastModifiedBy>Wendy Heywood</cp:lastModifiedBy>
  <cp:revision>3</cp:revision>
  <dcterms:created xsi:type="dcterms:W3CDTF">2015-07-13T16:03:00Z</dcterms:created>
  <dcterms:modified xsi:type="dcterms:W3CDTF">2015-09-06T16:47:45Z</dcterms:modified>
</cp:coreProperties>
</file>